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7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5AA00"/>
    <a:srgbClr val="296DC0"/>
    <a:srgbClr val="8300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23D718A-536F-4D23-8424-2157D1EB8417}" v="73" dt="2020-08-26T10:22:32.25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0" d="100"/>
          <a:sy n="70" d="100"/>
        </p:scale>
        <p:origin x="121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DBEA25-3F6D-413C-85E8-CB68D1943B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91CCB2F-0EFE-4AB8-8D87-C5536D236C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DCE310-D430-4607-8DFA-8BA3AF3765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DC8569-2B85-4E77-BCEC-3AF4A1ABD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28A36E-FE52-4FD4-B824-8FC84C813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8967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553F2-603C-4F84-B815-394E88624C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CDD223-5EC9-4506-A4DF-4EB2BCEF3D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A8CB7E-2932-4F7E-9D02-472880058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DBB2E4-2C10-453D-A592-A2A0804EF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C9B5D2-08F0-44D5-9BB3-78460C9A5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8006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735028-1BB6-4A51-8F0D-E91145E3B4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270BDB-D5E1-4CAA-8B9A-AF77A1B626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9C5707-54EB-4120-AD2E-E3CAEFACB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F16C41-D448-4F6D-8D46-DCDF8862D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8AB95F-F6E2-4C6D-B683-F59AE4ED0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99661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511346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A9C0EA-3D16-436A-9B7C-0A20866F9B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8EE250-C472-443A-A97F-6E8DE30FB2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4BF144-5D3D-4CDC-9173-5FC96CD8D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D94428-524C-4A04-8F85-DD7C35BB1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527D65-C648-41EF-9383-3D1140BD7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8301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5427F2-325B-4CBF-B0E0-B116DEE87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CB9A13-563E-4EC0-880B-31AA9EA3C6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91A77A-791A-4072-8C13-6A9A9284A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59FD54-3D02-4547-B5F8-46396E1B0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CB0706-C283-47D0-A580-6D52B7CB3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531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082834-61BC-42D4-B760-F15CB54224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012D87-6801-48B0-9E54-C5359C2C68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8E834D-A97B-480D-94A0-0A8D475041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28038E-9AA1-440A-8F3E-474715E7B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055556-5805-481D-9D94-F99861E23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8F9803-4150-4438-9CA5-54E576BD7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1558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6E65D-8853-4767-8839-175918FF24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F806D7-3D54-42CC-A03D-11DE449B32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C8FFE6-D200-4D03-8521-AD8D56358C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0C8717-8BE4-4877-BB0C-3AD93F0652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0F4A5D-2A77-42E1-BC72-AD454911EF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27055E-DD49-4B2D-A1A3-E87BAF2CA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116BCE3-F533-4F54-A11C-0A4183031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AD05C4-28C9-40E8-A888-892E7C08E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4214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DA29D6-67E8-4B3D-B62A-F5AF990829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4CBA79D-F96A-46A1-B51A-BD9FC733F3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00E3790-9AAD-4633-B614-E39EEF9CA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D17BBE-1126-47D6-9F32-038644198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7039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1741BC-B48B-4F3B-AF05-127F908BD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1B7A54-5592-4F3A-9B53-B263E214E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466875-B11A-41F8-B316-291029685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6002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7A3DE4-172D-49F7-8156-04A1530D3D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2416B5-1216-46D3-8814-9735904568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8099D0-4838-439C-8A99-541B258148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4EAAE5-2194-49C9-938A-55BD24646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BE38E6-7124-4DF7-A1B3-0E578F3F22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04-822C-475A-9006-820185E36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4745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48E009-B932-4D75-9B0A-19C9FDF61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F4C026F-B8BC-4091-83C7-3FE1FE3666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0F0BCC-9D64-4503-A21D-A00D08EA8F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3D0AC6-603D-4387-9FF5-BAC675CB5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930863-084D-4B0C-848C-FFFCA118F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A70BC6-322F-4CEA-949B-EA5BF5684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3952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FC0C9F-79C9-4EBD-B73A-1C5229EC6D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3EEEF6-C173-47A8-B9F2-F69749D3F0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F34535-FF6F-4979-ADB1-254650FA4E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9BF1F4-DF4E-4E99-88F2-EC50DC775C5A}" type="datetimeFigureOut">
              <a:rPr lang="en-GB" smtClean="0"/>
              <a:t>10/09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D4BA66-C3B2-46DB-B554-6CB287A160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264BE6-3F66-4AD2-BDF3-8FC7E4D01B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B787BD-CD68-4724-931B-73FAEE6733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5691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13" Type="http://schemas.openxmlformats.org/officeDocument/2006/relationships/image" Target="../media/image11.sv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4.png"/><Relationship Id="rId10" Type="http://schemas.openxmlformats.org/officeDocument/2006/relationships/image" Target="../media/image8.svg"/><Relationship Id="rId4" Type="http://schemas.openxmlformats.org/officeDocument/2006/relationships/image" Target="../media/image3.png"/><Relationship Id="rId9" Type="http://schemas.openxmlformats.org/officeDocument/2006/relationships/image" Target="../media/image6.pn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" y="0"/>
            <a:ext cx="9657806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100" b="1" dirty="0">
                <a:solidFill>
                  <a:schemeClr val="bg1"/>
                </a:solidFill>
              </a:rPr>
              <a:t>The long-acting C5 inhibitor, ravulizumab, is efficacious and safe in pediatric patients with atypical </a:t>
            </a:r>
            <a:r>
              <a:rPr lang="en-GB" sz="2100" b="1" dirty="0" err="1">
                <a:solidFill>
                  <a:schemeClr val="bg1"/>
                </a:solidFill>
              </a:rPr>
              <a:t>hemolytic</a:t>
            </a:r>
            <a:r>
              <a:rPr lang="en-GB" sz="2100" b="1" dirty="0">
                <a:solidFill>
                  <a:schemeClr val="bg1"/>
                </a:solidFill>
              </a:rPr>
              <a:t> uremic syndrome previously treated with eculizuma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Ravulizumab is safe and efficacious in patients switching from eculizumab treatment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Tanaka et al. 2019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246256" cy="11849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600" b="1" dirty="0">
                <a:solidFill>
                  <a:schemeClr val="bg1"/>
                </a:solidFill>
              </a:rPr>
              <a:t>CONCLUSION</a:t>
            </a:r>
            <a:r>
              <a:rPr lang="en-GB" sz="1600" dirty="0">
                <a:solidFill>
                  <a:schemeClr val="bg1"/>
                </a:solidFill>
              </a:rPr>
              <a:t>: Treatment with ravulizumab in pediatric patients with </a:t>
            </a:r>
            <a:r>
              <a:rPr lang="en-GB" sz="1600" dirty="0" err="1">
                <a:solidFill>
                  <a:schemeClr val="bg1"/>
                </a:solidFill>
              </a:rPr>
              <a:t>aHUS</a:t>
            </a:r>
            <a:r>
              <a:rPr lang="en-GB" sz="1600" dirty="0">
                <a:solidFill>
                  <a:schemeClr val="bg1"/>
                </a:solidFill>
              </a:rPr>
              <a:t> previously treated with eculizumab resulted in stable renal and hematologic parameters, with no unexpected safety concerns when administered every 4–8 weeks</a:t>
            </a:r>
          </a:p>
          <a:p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AF0819A7-4D56-4D18-B194-C64A1D19534A}"/>
              </a:ext>
            </a:extLst>
          </p:cNvPr>
          <p:cNvSpPr/>
          <p:nvPr/>
        </p:nvSpPr>
        <p:spPr>
          <a:xfrm>
            <a:off x="99228" y="2602473"/>
            <a:ext cx="8733687" cy="512346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Ravulizumab Efficacy following Switch from Eculizumab*</a:t>
            </a:r>
          </a:p>
        </p:txBody>
      </p:sp>
      <p:graphicFrame>
        <p:nvGraphicFramePr>
          <p:cNvPr id="39" name="Table 38">
            <a:extLst>
              <a:ext uri="{FF2B5EF4-FFF2-40B4-BE49-F238E27FC236}">
                <a16:creationId xmlns:a16="http://schemas.microsoft.com/office/drawing/2014/main" id="{BB4F0F62-FF54-4B83-841B-B71DBEF63C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7411956"/>
              </p:ext>
            </p:extLst>
          </p:nvPr>
        </p:nvGraphicFramePr>
        <p:xfrm>
          <a:off x="9052697" y="3186136"/>
          <a:ext cx="3097014" cy="2369412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668264">
                  <a:extLst>
                    <a:ext uri="{9D8B030D-6E8A-4147-A177-3AD203B41FA5}">
                      <a16:colId xmlns:a16="http://schemas.microsoft.com/office/drawing/2014/main" val="133390560"/>
                    </a:ext>
                  </a:extLst>
                </a:gridCol>
                <a:gridCol w="793750">
                  <a:extLst>
                    <a:ext uri="{9D8B030D-6E8A-4147-A177-3AD203B41FA5}">
                      <a16:colId xmlns:a16="http://schemas.microsoft.com/office/drawing/2014/main" val="777958500"/>
                    </a:ext>
                  </a:extLst>
                </a:gridCol>
                <a:gridCol w="635000">
                  <a:extLst>
                    <a:ext uri="{9D8B030D-6E8A-4147-A177-3AD203B41FA5}">
                      <a16:colId xmlns:a16="http://schemas.microsoft.com/office/drawing/2014/main" val="944301870"/>
                    </a:ext>
                  </a:extLst>
                </a:gridCol>
              </a:tblGrid>
              <a:tr h="16631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850" b="1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587" marR="27587" marT="5828" marB="0" anchor="ctr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GB" sz="850" b="1" dirty="0">
                          <a:effectLst/>
                        </a:rPr>
                        <a:t>Overall (N = 10)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/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 marL="27587" marR="27587" marT="5828" marB="0" anchor="ctr"/>
                </a:tc>
                <a:extLst>
                  <a:ext uri="{0D108BD9-81ED-4DB2-BD59-A6C34878D82A}">
                    <a16:rowId xmlns:a16="http://schemas.microsoft.com/office/drawing/2014/main" val="16434921"/>
                  </a:ext>
                </a:extLst>
              </a:tr>
              <a:tr h="166314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endParaRPr lang="en-GB" sz="850" b="1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n (%)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Events</a:t>
                      </a:r>
                      <a:endParaRPr lang="en-GB" sz="850" b="1" dirty="0"/>
                    </a:p>
                  </a:txBody>
                  <a:tcPr marL="27587" marR="27587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7965403"/>
                  </a:ext>
                </a:extLst>
              </a:tr>
              <a:tr h="16631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Any AE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10 (100)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66</a:t>
                      </a:r>
                      <a:endParaRPr lang="en-GB" sz="850" b="1" dirty="0"/>
                    </a:p>
                  </a:txBody>
                  <a:tcPr marL="27587" marR="27587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647597"/>
                  </a:ext>
                </a:extLst>
              </a:tr>
              <a:tr h="16631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>
                          <a:effectLst/>
                        </a:rPr>
                        <a:t>Any serious AE</a:t>
                      </a:r>
                      <a:endParaRPr lang="en-GB" sz="8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1 (10.0)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5</a:t>
                      </a:r>
                      <a:endParaRPr lang="en-GB" sz="850" b="1" dirty="0"/>
                    </a:p>
                  </a:txBody>
                  <a:tcPr marL="27587" marR="27587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8573850"/>
                  </a:ext>
                </a:extLst>
              </a:tr>
              <a:tr h="345778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TESAEs resulting in drug discontinuation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/>
                    </a:p>
                  </a:txBody>
                  <a:tcPr marL="27587" marR="27587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2146899"/>
                  </a:ext>
                </a:extLst>
              </a:tr>
              <a:tr h="345778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>
                          <a:effectLst/>
                        </a:rPr>
                        <a:t>TEAEs resulting in trial discontinuation</a:t>
                      </a:r>
                      <a:endParaRPr lang="en-GB" sz="8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/>
                    </a:p>
                  </a:txBody>
                  <a:tcPr marL="27587" marR="27587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2405707"/>
                  </a:ext>
                </a:extLst>
              </a:tr>
              <a:tr h="16631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>
                          <a:effectLst/>
                        </a:rPr>
                        <a:t>TEAEs during trial drug infusion</a:t>
                      </a:r>
                      <a:endParaRPr lang="en-GB" sz="8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2 (20.0)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4</a:t>
                      </a:r>
                      <a:endParaRPr lang="en-GB" sz="850" b="1" dirty="0"/>
                    </a:p>
                  </a:txBody>
                  <a:tcPr marL="27587" marR="27587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6501251"/>
                  </a:ext>
                </a:extLst>
              </a:tr>
              <a:tr h="16631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>
                          <a:effectLst/>
                        </a:rPr>
                        <a:t>TESAEs during trial drug infusion</a:t>
                      </a:r>
                      <a:endParaRPr lang="en-GB" sz="8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/>
                    </a:p>
                  </a:txBody>
                  <a:tcPr marL="27587" marR="27587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8366912"/>
                  </a:ext>
                </a:extLst>
              </a:tr>
              <a:tr h="16631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>
                          <a:effectLst/>
                        </a:rPr>
                        <a:t>Treatment-related AEs</a:t>
                      </a:r>
                      <a:endParaRPr lang="en-GB" sz="8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31083" marR="31083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2 (20.0)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31083" marR="31083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4</a:t>
                      </a:r>
                      <a:endParaRPr lang="en-GB" sz="850" b="1" dirty="0"/>
                    </a:p>
                  </a:txBody>
                  <a:tcPr marL="31083" marR="31083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7146611"/>
                  </a:ext>
                </a:extLst>
              </a:tr>
              <a:tr h="16631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>
                          <a:effectLst/>
                        </a:rPr>
                        <a:t>Meningococcal infections</a:t>
                      </a:r>
                      <a:endParaRPr lang="en-GB" sz="8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/>
                    </a:p>
                  </a:txBody>
                  <a:tcPr marL="27587" marR="27587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2321922"/>
                  </a:ext>
                </a:extLst>
              </a:tr>
              <a:tr h="16631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>
                          <a:effectLst/>
                        </a:rPr>
                        <a:t>Deaths</a:t>
                      </a:r>
                      <a:endParaRPr lang="en-GB" sz="850" b="1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Calibri" panose="020F0502020204030204" pitchFamily="34" charset="0"/>
                      </a:endParaRPr>
                    </a:p>
                  </a:txBody>
                  <a:tcPr marL="27587" marR="27587" marT="582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effectLst/>
                        </a:rPr>
                        <a:t>0</a:t>
                      </a:r>
                      <a:endParaRPr lang="en-GB" sz="850" b="1" dirty="0"/>
                    </a:p>
                  </a:txBody>
                  <a:tcPr marL="27587" marR="27587" marT="5828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4002185"/>
                  </a:ext>
                </a:extLst>
              </a:tr>
            </a:tbl>
          </a:graphicData>
        </a:graphic>
      </p:graphicFrame>
      <p:sp>
        <p:nvSpPr>
          <p:cNvPr id="41" name="Rectangle 40">
            <a:extLst>
              <a:ext uri="{FF2B5EF4-FFF2-40B4-BE49-F238E27FC236}">
                <a16:creationId xmlns:a16="http://schemas.microsoft.com/office/drawing/2014/main" id="{6DAF6D4A-0739-4B1E-976A-CFD11FC108F5}"/>
              </a:ext>
            </a:extLst>
          </p:cNvPr>
          <p:cNvSpPr/>
          <p:nvPr/>
        </p:nvSpPr>
        <p:spPr>
          <a:xfrm>
            <a:off x="9052697" y="2602473"/>
            <a:ext cx="3097014" cy="512346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>
                <a:solidFill>
                  <a:srgbClr val="65AA00"/>
                </a:solidFill>
              </a:rPr>
              <a:t>Ravulizumab Safety following Switch from Eculizumab*</a:t>
            </a:r>
          </a:p>
        </p:txBody>
      </p:sp>
      <p:grpSp>
        <p:nvGrpSpPr>
          <p:cNvPr id="94" name="Group 93">
            <a:extLst>
              <a:ext uri="{FF2B5EF4-FFF2-40B4-BE49-F238E27FC236}">
                <a16:creationId xmlns:a16="http://schemas.microsoft.com/office/drawing/2014/main" id="{10834200-FD0A-4C4A-A17F-0E579266261C}"/>
              </a:ext>
            </a:extLst>
          </p:cNvPr>
          <p:cNvGrpSpPr/>
          <p:nvPr/>
        </p:nvGrpSpPr>
        <p:grpSpPr>
          <a:xfrm>
            <a:off x="99228" y="3238090"/>
            <a:ext cx="8733687" cy="2013783"/>
            <a:chOff x="99228" y="3159710"/>
            <a:chExt cx="8733687" cy="2013783"/>
          </a:xfrm>
        </p:grpSpPr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ADFBCA53-C47A-48CC-93C6-85706A93861A}"/>
                </a:ext>
              </a:extLst>
            </p:cNvPr>
            <p:cNvSpPr/>
            <p:nvPr/>
          </p:nvSpPr>
          <p:spPr>
            <a:xfrm>
              <a:off x="99228" y="3159710"/>
              <a:ext cx="2081563" cy="459247"/>
            </a:xfrm>
            <a:prstGeom prst="rect">
              <a:avLst/>
            </a:prstGeom>
            <a:solidFill>
              <a:srgbClr val="65AA00"/>
            </a:solidFill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b="1" dirty="0"/>
                <a:t>eGFR</a:t>
              </a:r>
            </a:p>
            <a:p>
              <a:pPr algn="ctr"/>
              <a:r>
                <a:rPr lang="en-GB" sz="1400" b="1" dirty="0"/>
                <a:t>mL/min/1.73m</a:t>
              </a:r>
              <a:r>
                <a:rPr lang="en-GB" sz="1400" b="1" baseline="30000" dirty="0"/>
                <a:t>2</a:t>
              </a:r>
              <a:endParaRPr lang="en-GB" sz="1400" b="1" dirty="0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5FD03B9B-DAD0-4AE1-A46C-D43C5876E7BC}"/>
                </a:ext>
              </a:extLst>
            </p:cNvPr>
            <p:cNvSpPr/>
            <p:nvPr/>
          </p:nvSpPr>
          <p:spPr>
            <a:xfrm>
              <a:off x="2316603" y="3159710"/>
              <a:ext cx="2081563" cy="459247"/>
            </a:xfrm>
            <a:prstGeom prst="rect">
              <a:avLst/>
            </a:prstGeom>
            <a:solidFill>
              <a:srgbClr val="65AA00"/>
            </a:solidFill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b="1" dirty="0"/>
                <a:t>Hemoglobin</a:t>
              </a:r>
            </a:p>
            <a:p>
              <a:pPr algn="ctr"/>
              <a:r>
                <a:rPr lang="en-GB" sz="1400" b="1" dirty="0"/>
                <a:t>g/L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84C3149D-0030-4586-BB22-9A2DE4B08C11}"/>
                </a:ext>
              </a:extLst>
            </p:cNvPr>
            <p:cNvSpPr/>
            <p:nvPr/>
          </p:nvSpPr>
          <p:spPr>
            <a:xfrm>
              <a:off x="4533978" y="3159710"/>
              <a:ext cx="2081563" cy="459247"/>
            </a:xfrm>
            <a:prstGeom prst="rect">
              <a:avLst/>
            </a:prstGeom>
            <a:solidFill>
              <a:srgbClr val="65AA00"/>
            </a:solidFill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b="1" dirty="0"/>
                <a:t>Lactate Dehydrogenase</a:t>
              </a:r>
            </a:p>
            <a:p>
              <a:pPr algn="ctr"/>
              <a:r>
                <a:rPr lang="en-GB" sz="1400" b="1" dirty="0"/>
                <a:t>U/L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9919621B-85F8-4C88-9247-44E2D36155A3}"/>
                </a:ext>
              </a:extLst>
            </p:cNvPr>
            <p:cNvSpPr/>
            <p:nvPr/>
          </p:nvSpPr>
          <p:spPr>
            <a:xfrm>
              <a:off x="6751352" y="3159710"/>
              <a:ext cx="2081563" cy="459247"/>
            </a:xfrm>
            <a:prstGeom prst="rect">
              <a:avLst/>
            </a:prstGeom>
            <a:solidFill>
              <a:srgbClr val="65AA00"/>
            </a:solidFill>
            <a:ln w="41275">
              <a:solidFill>
                <a:srgbClr val="65AA0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b="1" dirty="0"/>
                <a:t>Platelet Count</a:t>
              </a:r>
            </a:p>
            <a:p>
              <a:pPr algn="ctr"/>
              <a:r>
                <a:rPr lang="en-GB" sz="1400" b="1" dirty="0"/>
                <a:t>X10</a:t>
              </a:r>
              <a:r>
                <a:rPr lang="en-GB" sz="1400" b="1" baseline="30000" dirty="0"/>
                <a:t>9</a:t>
              </a:r>
              <a:r>
                <a:rPr lang="en-GB" sz="1400" b="1" dirty="0"/>
                <a:t>/L</a:t>
              </a:r>
            </a:p>
          </p:txBody>
        </p:sp>
        <p:pic>
          <p:nvPicPr>
            <p:cNvPr id="38" name="Picture 37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1B93EB79-4E63-4B26-9418-9F34B80CF0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89" t="67147" b="1995"/>
            <a:stretch/>
          </p:blipFill>
          <p:spPr>
            <a:xfrm>
              <a:off x="2316603" y="3851095"/>
              <a:ext cx="2080800" cy="1322398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9B824D6-6BEA-4A7C-AF37-A8B3EA7C1E1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34359" y="3853706"/>
              <a:ext cx="2080800" cy="1317177"/>
            </a:xfrm>
            <a:prstGeom prst="rect">
              <a:avLst/>
            </a:prstGeom>
          </p:spPr>
        </p:pic>
        <p:pic>
          <p:nvPicPr>
            <p:cNvPr id="50" name="Picture 49" descr="A close up of a map&#10;&#10;Description automatically generated">
              <a:extLst>
                <a:ext uri="{FF2B5EF4-FFF2-40B4-BE49-F238E27FC236}">
                  <a16:creationId xmlns:a16="http://schemas.microsoft.com/office/drawing/2014/main" id="{A5AC32D9-830C-4A37-8924-A6F7AE2CB9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44" b="6697"/>
            <a:stretch/>
          </p:blipFill>
          <p:spPr>
            <a:xfrm>
              <a:off x="99228" y="3852747"/>
              <a:ext cx="2080800" cy="1319094"/>
            </a:xfrm>
            <a:prstGeom prst="rect">
              <a:avLst/>
            </a:prstGeom>
          </p:spPr>
        </p:pic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1D78E7A6-D5EA-492D-8304-100023C583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saturation sat="40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85" b="69042"/>
            <a:stretch/>
          </p:blipFill>
          <p:spPr>
            <a:xfrm>
              <a:off x="6751352" y="3855545"/>
              <a:ext cx="2080800" cy="1313499"/>
            </a:xfrm>
            <a:prstGeom prst="rect">
              <a:avLst/>
            </a:prstGeom>
          </p:spPr>
        </p:pic>
      </p:grpSp>
      <p:sp>
        <p:nvSpPr>
          <p:cNvPr id="58" name="TextBox 57">
            <a:extLst>
              <a:ext uri="{FF2B5EF4-FFF2-40B4-BE49-F238E27FC236}">
                <a16:creationId xmlns:a16="http://schemas.microsoft.com/office/drawing/2014/main" id="{1D09B242-BF91-458F-89E3-0E4116EF0705}"/>
              </a:ext>
            </a:extLst>
          </p:cNvPr>
          <p:cNvSpPr txBox="1"/>
          <p:nvPr/>
        </p:nvSpPr>
        <p:spPr>
          <a:xfrm>
            <a:off x="98465" y="5209688"/>
            <a:ext cx="87336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*Eculizumab discontinued 2-weeks pre-baseline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BFF4554D-3E8F-45C6-A9EF-AAAE515A4964}"/>
              </a:ext>
            </a:extLst>
          </p:cNvPr>
          <p:cNvGrpSpPr/>
          <p:nvPr/>
        </p:nvGrpSpPr>
        <p:grpSpPr>
          <a:xfrm>
            <a:off x="4207341" y="1732673"/>
            <a:ext cx="6140244" cy="678694"/>
            <a:chOff x="4273877" y="1743373"/>
            <a:chExt cx="6140244" cy="678694"/>
          </a:xfrm>
        </p:grpSpPr>
        <p:cxnSp>
          <p:nvCxnSpPr>
            <p:cNvPr id="61" name="Connector: Curved 60">
              <a:extLst>
                <a:ext uri="{FF2B5EF4-FFF2-40B4-BE49-F238E27FC236}">
                  <a16:creationId xmlns:a16="http://schemas.microsoft.com/office/drawing/2014/main" id="{C3D7B466-BDF5-43DB-A3B7-AD80472A8F4A}"/>
                </a:ext>
              </a:extLst>
            </p:cNvPr>
            <p:cNvCxnSpPr>
              <a:cxnSpLocks/>
              <a:stCxn id="7" idx="0"/>
              <a:endCxn id="14" idx="2"/>
            </p:cNvCxnSpPr>
            <p:nvPr/>
          </p:nvCxnSpPr>
          <p:spPr>
            <a:xfrm rot="16200000" flipH="1">
              <a:off x="7003040" y="629194"/>
              <a:ext cx="611553" cy="2887365"/>
            </a:xfrm>
            <a:prstGeom prst="curvedConnector5">
              <a:avLst>
                <a:gd name="adj1" fmla="val -18690"/>
                <a:gd name="adj2" fmla="val 49144"/>
                <a:gd name="adj3" fmla="val 121805"/>
              </a:avLst>
            </a:prstGeom>
            <a:ln w="38100">
              <a:solidFill>
                <a:srgbClr val="830049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4079B015-EA21-41C4-A1E0-A54E85C084AA}"/>
                </a:ext>
              </a:extLst>
            </p:cNvPr>
            <p:cNvGrpSpPr/>
            <p:nvPr/>
          </p:nvGrpSpPr>
          <p:grpSpPr>
            <a:xfrm>
              <a:off x="4273877" y="1743373"/>
              <a:ext cx="6140244" cy="678694"/>
              <a:chOff x="4273877" y="1743373"/>
              <a:chExt cx="6140244" cy="678694"/>
            </a:xfrm>
          </p:grpSpPr>
          <p:cxnSp>
            <p:nvCxnSpPr>
              <p:cNvPr id="66" name="Connector: Curved 65">
                <a:extLst>
                  <a:ext uri="{FF2B5EF4-FFF2-40B4-BE49-F238E27FC236}">
                    <a16:creationId xmlns:a16="http://schemas.microsoft.com/office/drawing/2014/main" id="{07ABA3F1-1D22-447E-A134-E573DDFC26A9}"/>
                  </a:ext>
                </a:extLst>
              </p:cNvPr>
              <p:cNvCxnSpPr>
                <a:cxnSpLocks/>
                <a:stCxn id="7" idx="2"/>
                <a:endCxn id="14" idx="0"/>
              </p:cNvCxnSpPr>
              <p:nvPr/>
            </p:nvCxnSpPr>
            <p:spPr>
              <a:xfrm rot="5400000" flipH="1" flipV="1">
                <a:off x="7003040" y="629194"/>
                <a:ext cx="611553" cy="2887365"/>
              </a:xfrm>
              <a:prstGeom prst="curvedConnector5">
                <a:avLst>
                  <a:gd name="adj1" fmla="val -23362"/>
                  <a:gd name="adj2" fmla="val 49144"/>
                  <a:gd name="adj3" fmla="val 117132"/>
                </a:avLst>
              </a:prstGeom>
              <a:ln w="38100">
                <a:solidFill>
                  <a:srgbClr val="830049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Rectangle 77">
                <a:extLst>
                  <a:ext uri="{FF2B5EF4-FFF2-40B4-BE49-F238E27FC236}">
                    <a16:creationId xmlns:a16="http://schemas.microsoft.com/office/drawing/2014/main" id="{383257B5-ABA1-4A8C-A939-88FFB04A6DB7}"/>
                  </a:ext>
                </a:extLst>
              </p:cNvPr>
              <p:cNvSpPr/>
              <p:nvPr/>
            </p:nvSpPr>
            <p:spPr>
              <a:xfrm>
                <a:off x="6676447" y="1936880"/>
                <a:ext cx="1196235" cy="295489"/>
              </a:xfrm>
              <a:prstGeom prst="rect">
                <a:avLst/>
              </a:prstGeom>
              <a:solidFill>
                <a:schemeClr val="bg1"/>
              </a:solidFill>
              <a:ln w="41275">
                <a:solidFill>
                  <a:srgbClr val="AA0065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dirty="0">
                    <a:solidFill>
                      <a:srgbClr val="AA0065"/>
                    </a:solidFill>
                  </a:rPr>
                  <a:t>Switch</a:t>
                </a:r>
              </a:p>
            </p:txBody>
          </p: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97CEB534-7530-432F-82AB-872E966A3821}"/>
                  </a:ext>
                </a:extLst>
              </p:cNvPr>
              <p:cNvGrpSpPr/>
              <p:nvPr/>
            </p:nvGrpSpPr>
            <p:grpSpPr>
              <a:xfrm>
                <a:off x="4273877" y="1743373"/>
                <a:ext cx="6140244" cy="678694"/>
                <a:chOff x="4273877" y="1743373"/>
                <a:chExt cx="6140244" cy="678694"/>
              </a:xfrm>
            </p:grpSpPr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FCA843EE-F0EA-4831-B9CF-827BA79593B4}"/>
                    </a:ext>
                  </a:extLst>
                </p:cNvPr>
                <p:cNvGrpSpPr/>
                <p:nvPr/>
              </p:nvGrpSpPr>
              <p:grpSpPr>
                <a:xfrm>
                  <a:off x="4273877" y="1763062"/>
                  <a:ext cx="5592260" cy="659005"/>
                  <a:chOff x="4273877" y="1763062"/>
                  <a:chExt cx="5592260" cy="659005"/>
                </a:xfrm>
              </p:grpSpPr>
              <p:grpSp>
                <p:nvGrpSpPr>
                  <p:cNvPr id="34" name="Group 33">
                    <a:extLst>
                      <a:ext uri="{FF2B5EF4-FFF2-40B4-BE49-F238E27FC236}">
                        <a16:creationId xmlns:a16="http://schemas.microsoft.com/office/drawing/2014/main" id="{62328308-8E7F-4CA9-BBC6-5777FDFE198A}"/>
                      </a:ext>
                    </a:extLst>
                  </p:cNvPr>
                  <p:cNvGrpSpPr>
                    <a:grpSpLocks noChangeAspect="1"/>
                  </p:cNvGrpSpPr>
                  <p:nvPr/>
                </p:nvGrpSpPr>
                <p:grpSpPr>
                  <a:xfrm>
                    <a:off x="4826864" y="1767100"/>
                    <a:ext cx="5039273" cy="611554"/>
                    <a:chOff x="3075112" y="1807140"/>
                    <a:chExt cx="3753829" cy="455555"/>
                  </a:xfrm>
                </p:grpSpPr>
                <p:sp>
                  <p:nvSpPr>
                    <p:cNvPr id="7" name="Rectangle 6">
                      <a:extLst>
                        <a:ext uri="{FF2B5EF4-FFF2-40B4-BE49-F238E27FC236}">
                          <a16:creationId xmlns:a16="http://schemas.microsoft.com/office/drawing/2014/main" id="{1738EECF-65F5-4AD0-BE3D-48B6C69E61D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304272" y="1807140"/>
                      <a:ext cx="1088528" cy="455554"/>
                    </a:xfrm>
                    <a:prstGeom prst="rect">
                      <a:avLst/>
                    </a:prstGeom>
                    <a:solidFill>
                      <a:srgbClr val="296DC0"/>
                    </a:solidFill>
                    <a:ln w="41275">
                      <a:noFill/>
                      <a:round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GB" sz="1600" dirty="0"/>
                        <a:t>Eculizumab</a:t>
                      </a:r>
                    </a:p>
                    <a:p>
                      <a:pPr algn="ctr"/>
                      <a:r>
                        <a:rPr lang="en-GB" sz="1600" dirty="0"/>
                        <a:t>Every 2 weeks</a:t>
                      </a:r>
                    </a:p>
                  </p:txBody>
                </p:sp>
                <p:sp>
                  <p:nvSpPr>
                    <p:cNvPr id="8" name="Freeform: Shape 46">
                      <a:extLst>
                        <a:ext uri="{FF2B5EF4-FFF2-40B4-BE49-F238E27FC236}">
                          <a16:creationId xmlns:a16="http://schemas.microsoft.com/office/drawing/2014/main" id="{64FD6F07-53E6-4E3D-9A27-E78D309ADF22}"/>
                        </a:ext>
                      </a:extLst>
                    </p:cNvPr>
                    <p:cNvSpPr>
                      <a:spLocks noChangeAspect="1"/>
                    </p:cNvSpPr>
                    <p:nvPr/>
                  </p:nvSpPr>
                  <p:spPr>
                    <a:xfrm>
                      <a:off x="3075112" y="1807140"/>
                      <a:ext cx="222716" cy="455555"/>
                    </a:xfrm>
                    <a:custGeom>
                      <a:avLst/>
                      <a:gdLst>
                        <a:gd name="connsiteX0" fmla="*/ 427832 w 855663"/>
                        <a:gd name="connsiteY0" fmla="*/ 350043 h 1750218"/>
                        <a:gd name="connsiteX1" fmla="*/ 556181 w 855663"/>
                        <a:gd name="connsiteY1" fmla="*/ 365601 h 1750218"/>
                        <a:gd name="connsiteX2" fmla="*/ 719535 w 855663"/>
                        <a:gd name="connsiteY2" fmla="*/ 451168 h 1750218"/>
                        <a:gd name="connsiteX3" fmla="*/ 742872 w 855663"/>
                        <a:gd name="connsiteY3" fmla="*/ 493950 h 1750218"/>
                        <a:gd name="connsiteX4" fmla="*/ 851774 w 855663"/>
                        <a:gd name="connsiteY4" fmla="*/ 956786 h 1750218"/>
                        <a:gd name="connsiteX5" fmla="*/ 855663 w 855663"/>
                        <a:gd name="connsiteY5" fmla="*/ 976232 h 1750218"/>
                        <a:gd name="connsiteX6" fmla="*/ 777876 w 855663"/>
                        <a:gd name="connsiteY6" fmla="*/ 1054020 h 1750218"/>
                        <a:gd name="connsiteX7" fmla="*/ 703977 w 855663"/>
                        <a:gd name="connsiteY7" fmla="*/ 995680 h 1750218"/>
                        <a:gd name="connsiteX8" fmla="*/ 622301 w 855663"/>
                        <a:gd name="connsiteY8" fmla="*/ 657304 h 1750218"/>
                        <a:gd name="connsiteX9" fmla="*/ 622301 w 855663"/>
                        <a:gd name="connsiteY9" fmla="*/ 1750218 h 1750218"/>
                        <a:gd name="connsiteX10" fmla="*/ 466726 w 855663"/>
                        <a:gd name="connsiteY10" fmla="*/ 1750218 h 1750218"/>
                        <a:gd name="connsiteX11" fmla="*/ 466726 w 855663"/>
                        <a:gd name="connsiteY11" fmla="*/ 1050131 h 1750218"/>
                        <a:gd name="connsiteX12" fmla="*/ 388938 w 855663"/>
                        <a:gd name="connsiteY12" fmla="*/ 1050131 h 1750218"/>
                        <a:gd name="connsiteX13" fmla="*/ 388938 w 855663"/>
                        <a:gd name="connsiteY13" fmla="*/ 1750218 h 1750218"/>
                        <a:gd name="connsiteX14" fmla="*/ 233363 w 855663"/>
                        <a:gd name="connsiteY14" fmla="*/ 1750218 h 1750218"/>
                        <a:gd name="connsiteX15" fmla="*/ 233363 w 855663"/>
                        <a:gd name="connsiteY15" fmla="*/ 661193 h 1750218"/>
                        <a:gd name="connsiteX16" fmla="*/ 151686 w 855663"/>
                        <a:gd name="connsiteY16" fmla="*/ 999569 h 1750218"/>
                        <a:gd name="connsiteX17" fmla="*/ 77788 w 855663"/>
                        <a:gd name="connsiteY17" fmla="*/ 1057910 h 1750218"/>
                        <a:gd name="connsiteX18" fmla="*/ 0 w 855663"/>
                        <a:gd name="connsiteY18" fmla="*/ 980123 h 1750218"/>
                        <a:gd name="connsiteX19" fmla="*/ 3889 w 855663"/>
                        <a:gd name="connsiteY19" fmla="*/ 960675 h 1750218"/>
                        <a:gd name="connsiteX20" fmla="*/ 112792 w 855663"/>
                        <a:gd name="connsiteY20" fmla="*/ 497840 h 1750218"/>
                        <a:gd name="connsiteX21" fmla="*/ 136129 w 855663"/>
                        <a:gd name="connsiteY21" fmla="*/ 455057 h 1750218"/>
                        <a:gd name="connsiteX22" fmla="*/ 299482 w 855663"/>
                        <a:gd name="connsiteY22" fmla="*/ 369490 h 1750218"/>
                        <a:gd name="connsiteX23" fmla="*/ 427832 w 855663"/>
                        <a:gd name="connsiteY23" fmla="*/ 350043 h 1750218"/>
                        <a:gd name="connsiteX24" fmla="*/ 427831 w 855663"/>
                        <a:gd name="connsiteY24" fmla="*/ 0 h 1750218"/>
                        <a:gd name="connsiteX25" fmla="*/ 583406 w 855663"/>
                        <a:gd name="connsiteY25" fmla="*/ 155575 h 1750218"/>
                        <a:gd name="connsiteX26" fmla="*/ 427831 w 855663"/>
                        <a:gd name="connsiteY26" fmla="*/ 311150 h 1750218"/>
                        <a:gd name="connsiteX27" fmla="*/ 272256 w 855663"/>
                        <a:gd name="connsiteY27" fmla="*/ 155575 h 1750218"/>
                        <a:gd name="connsiteX28" fmla="*/ 427831 w 855663"/>
                        <a:gd name="connsiteY28" fmla="*/ 0 h 1750218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</a:cxnLst>
                      <a:rect l="l" t="t" r="r" b="b"/>
                      <a:pathLst>
                        <a:path w="855663" h="1750218">
                          <a:moveTo>
                            <a:pt x="427832" y="350043"/>
                          </a:moveTo>
                          <a:cubicBezTo>
                            <a:pt x="470615" y="350043"/>
                            <a:pt x="513398" y="357821"/>
                            <a:pt x="556181" y="365601"/>
                          </a:cubicBezTo>
                          <a:cubicBezTo>
                            <a:pt x="618412" y="385047"/>
                            <a:pt x="672862" y="412273"/>
                            <a:pt x="719535" y="451168"/>
                          </a:cubicBezTo>
                          <a:cubicBezTo>
                            <a:pt x="731203" y="462835"/>
                            <a:pt x="738983" y="478392"/>
                            <a:pt x="742872" y="493950"/>
                          </a:cubicBezTo>
                          <a:lnTo>
                            <a:pt x="851774" y="956786"/>
                          </a:lnTo>
                          <a:cubicBezTo>
                            <a:pt x="851774" y="960675"/>
                            <a:pt x="855663" y="968454"/>
                            <a:pt x="855663" y="976232"/>
                          </a:cubicBezTo>
                          <a:cubicBezTo>
                            <a:pt x="855663" y="1019016"/>
                            <a:pt x="820659" y="1054020"/>
                            <a:pt x="777876" y="1054020"/>
                          </a:cubicBezTo>
                          <a:cubicBezTo>
                            <a:pt x="742872" y="1054020"/>
                            <a:pt x="711757" y="1026795"/>
                            <a:pt x="703977" y="995680"/>
                          </a:cubicBezTo>
                          <a:lnTo>
                            <a:pt x="622301" y="657304"/>
                          </a:lnTo>
                          <a:lnTo>
                            <a:pt x="622301" y="1750218"/>
                          </a:lnTo>
                          <a:lnTo>
                            <a:pt x="466726" y="1750218"/>
                          </a:lnTo>
                          <a:lnTo>
                            <a:pt x="466726" y="1050131"/>
                          </a:lnTo>
                          <a:lnTo>
                            <a:pt x="388938" y="1050131"/>
                          </a:lnTo>
                          <a:lnTo>
                            <a:pt x="388938" y="1750218"/>
                          </a:lnTo>
                          <a:lnTo>
                            <a:pt x="233363" y="1750218"/>
                          </a:lnTo>
                          <a:lnTo>
                            <a:pt x="233363" y="661193"/>
                          </a:lnTo>
                          <a:lnTo>
                            <a:pt x="151686" y="999569"/>
                          </a:lnTo>
                          <a:cubicBezTo>
                            <a:pt x="143907" y="1030684"/>
                            <a:pt x="112792" y="1057910"/>
                            <a:pt x="77788" y="1057910"/>
                          </a:cubicBezTo>
                          <a:cubicBezTo>
                            <a:pt x="35004" y="1057910"/>
                            <a:pt x="0" y="1022905"/>
                            <a:pt x="0" y="980123"/>
                          </a:cubicBezTo>
                          <a:cubicBezTo>
                            <a:pt x="0" y="972343"/>
                            <a:pt x="3889" y="964564"/>
                            <a:pt x="3889" y="960675"/>
                          </a:cubicBezTo>
                          <a:lnTo>
                            <a:pt x="112792" y="497840"/>
                          </a:lnTo>
                          <a:cubicBezTo>
                            <a:pt x="116682" y="482281"/>
                            <a:pt x="124460" y="466725"/>
                            <a:pt x="136129" y="455057"/>
                          </a:cubicBezTo>
                          <a:cubicBezTo>
                            <a:pt x="182801" y="416162"/>
                            <a:pt x="237252" y="385047"/>
                            <a:pt x="299482" y="369490"/>
                          </a:cubicBezTo>
                          <a:cubicBezTo>
                            <a:pt x="342265" y="357821"/>
                            <a:pt x="385049" y="350043"/>
                            <a:pt x="427832" y="350043"/>
                          </a:cubicBezTo>
                          <a:close/>
                          <a:moveTo>
                            <a:pt x="427831" y="0"/>
                          </a:moveTo>
                          <a:cubicBezTo>
                            <a:pt x="513753" y="0"/>
                            <a:pt x="583406" y="69653"/>
                            <a:pt x="583406" y="155575"/>
                          </a:cubicBezTo>
                          <a:cubicBezTo>
                            <a:pt x="583406" y="241496"/>
                            <a:pt x="513753" y="311150"/>
                            <a:pt x="427831" y="311150"/>
                          </a:cubicBezTo>
                          <a:cubicBezTo>
                            <a:pt x="341910" y="311150"/>
                            <a:pt x="272256" y="241496"/>
                            <a:pt x="272256" y="155575"/>
                          </a:cubicBezTo>
                          <a:cubicBezTo>
                            <a:pt x="272256" y="69653"/>
                            <a:pt x="341910" y="0"/>
                            <a:pt x="427831" y="0"/>
                          </a:cubicBezTo>
                          <a:close/>
                        </a:path>
                      </a:pathLst>
                    </a:custGeom>
                    <a:solidFill>
                      <a:srgbClr val="296DC0"/>
                    </a:solidFill>
                    <a:ln w="15081" cap="flat">
                      <a:noFill/>
                      <a:prstDash val="solid"/>
                      <a:miter/>
                    </a:ln>
                  </p:spPr>
                  <p:txBody>
                    <a:bodyPr wrap="square" rtlCol="0" anchor="ctr">
                      <a:noAutofit/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15" name="Freeform: Shape 46">
                      <a:extLst>
                        <a:ext uri="{FF2B5EF4-FFF2-40B4-BE49-F238E27FC236}">
                          <a16:creationId xmlns:a16="http://schemas.microsoft.com/office/drawing/2014/main" id="{1BB9B157-1FAA-4CE5-9C65-513F8B546BFB}"/>
                        </a:ext>
                      </a:extLst>
                    </p:cNvPr>
                    <p:cNvSpPr>
                      <a:spLocks noChangeAspect="1"/>
                    </p:cNvSpPr>
                    <p:nvPr/>
                  </p:nvSpPr>
                  <p:spPr>
                    <a:xfrm>
                      <a:off x="6607461" y="1808404"/>
                      <a:ext cx="221480" cy="453027"/>
                    </a:xfrm>
                    <a:custGeom>
                      <a:avLst/>
                      <a:gdLst>
                        <a:gd name="connsiteX0" fmla="*/ 427832 w 855663"/>
                        <a:gd name="connsiteY0" fmla="*/ 350043 h 1750218"/>
                        <a:gd name="connsiteX1" fmla="*/ 556181 w 855663"/>
                        <a:gd name="connsiteY1" fmla="*/ 365601 h 1750218"/>
                        <a:gd name="connsiteX2" fmla="*/ 719535 w 855663"/>
                        <a:gd name="connsiteY2" fmla="*/ 451168 h 1750218"/>
                        <a:gd name="connsiteX3" fmla="*/ 742872 w 855663"/>
                        <a:gd name="connsiteY3" fmla="*/ 493950 h 1750218"/>
                        <a:gd name="connsiteX4" fmla="*/ 851774 w 855663"/>
                        <a:gd name="connsiteY4" fmla="*/ 956786 h 1750218"/>
                        <a:gd name="connsiteX5" fmla="*/ 855663 w 855663"/>
                        <a:gd name="connsiteY5" fmla="*/ 976232 h 1750218"/>
                        <a:gd name="connsiteX6" fmla="*/ 777876 w 855663"/>
                        <a:gd name="connsiteY6" fmla="*/ 1054020 h 1750218"/>
                        <a:gd name="connsiteX7" fmla="*/ 703977 w 855663"/>
                        <a:gd name="connsiteY7" fmla="*/ 995680 h 1750218"/>
                        <a:gd name="connsiteX8" fmla="*/ 622301 w 855663"/>
                        <a:gd name="connsiteY8" fmla="*/ 657304 h 1750218"/>
                        <a:gd name="connsiteX9" fmla="*/ 622301 w 855663"/>
                        <a:gd name="connsiteY9" fmla="*/ 1750218 h 1750218"/>
                        <a:gd name="connsiteX10" fmla="*/ 466726 w 855663"/>
                        <a:gd name="connsiteY10" fmla="*/ 1750218 h 1750218"/>
                        <a:gd name="connsiteX11" fmla="*/ 466726 w 855663"/>
                        <a:gd name="connsiteY11" fmla="*/ 1050131 h 1750218"/>
                        <a:gd name="connsiteX12" fmla="*/ 388938 w 855663"/>
                        <a:gd name="connsiteY12" fmla="*/ 1050131 h 1750218"/>
                        <a:gd name="connsiteX13" fmla="*/ 388938 w 855663"/>
                        <a:gd name="connsiteY13" fmla="*/ 1750218 h 1750218"/>
                        <a:gd name="connsiteX14" fmla="*/ 233363 w 855663"/>
                        <a:gd name="connsiteY14" fmla="*/ 1750218 h 1750218"/>
                        <a:gd name="connsiteX15" fmla="*/ 233363 w 855663"/>
                        <a:gd name="connsiteY15" fmla="*/ 661193 h 1750218"/>
                        <a:gd name="connsiteX16" fmla="*/ 151686 w 855663"/>
                        <a:gd name="connsiteY16" fmla="*/ 999569 h 1750218"/>
                        <a:gd name="connsiteX17" fmla="*/ 77788 w 855663"/>
                        <a:gd name="connsiteY17" fmla="*/ 1057910 h 1750218"/>
                        <a:gd name="connsiteX18" fmla="*/ 0 w 855663"/>
                        <a:gd name="connsiteY18" fmla="*/ 980123 h 1750218"/>
                        <a:gd name="connsiteX19" fmla="*/ 3889 w 855663"/>
                        <a:gd name="connsiteY19" fmla="*/ 960675 h 1750218"/>
                        <a:gd name="connsiteX20" fmla="*/ 112792 w 855663"/>
                        <a:gd name="connsiteY20" fmla="*/ 497840 h 1750218"/>
                        <a:gd name="connsiteX21" fmla="*/ 136129 w 855663"/>
                        <a:gd name="connsiteY21" fmla="*/ 455057 h 1750218"/>
                        <a:gd name="connsiteX22" fmla="*/ 299482 w 855663"/>
                        <a:gd name="connsiteY22" fmla="*/ 369490 h 1750218"/>
                        <a:gd name="connsiteX23" fmla="*/ 427832 w 855663"/>
                        <a:gd name="connsiteY23" fmla="*/ 350043 h 1750218"/>
                        <a:gd name="connsiteX24" fmla="*/ 427831 w 855663"/>
                        <a:gd name="connsiteY24" fmla="*/ 0 h 1750218"/>
                        <a:gd name="connsiteX25" fmla="*/ 583406 w 855663"/>
                        <a:gd name="connsiteY25" fmla="*/ 155575 h 1750218"/>
                        <a:gd name="connsiteX26" fmla="*/ 427831 w 855663"/>
                        <a:gd name="connsiteY26" fmla="*/ 311150 h 1750218"/>
                        <a:gd name="connsiteX27" fmla="*/ 272256 w 855663"/>
                        <a:gd name="connsiteY27" fmla="*/ 155575 h 1750218"/>
                        <a:gd name="connsiteX28" fmla="*/ 427831 w 855663"/>
                        <a:gd name="connsiteY28" fmla="*/ 0 h 1750218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</a:cxnLst>
                      <a:rect l="l" t="t" r="r" b="b"/>
                      <a:pathLst>
                        <a:path w="855663" h="1750218">
                          <a:moveTo>
                            <a:pt x="427832" y="350043"/>
                          </a:moveTo>
                          <a:cubicBezTo>
                            <a:pt x="470615" y="350043"/>
                            <a:pt x="513398" y="357821"/>
                            <a:pt x="556181" y="365601"/>
                          </a:cubicBezTo>
                          <a:cubicBezTo>
                            <a:pt x="618412" y="385047"/>
                            <a:pt x="672862" y="412273"/>
                            <a:pt x="719535" y="451168"/>
                          </a:cubicBezTo>
                          <a:cubicBezTo>
                            <a:pt x="731203" y="462835"/>
                            <a:pt x="738983" y="478392"/>
                            <a:pt x="742872" y="493950"/>
                          </a:cubicBezTo>
                          <a:lnTo>
                            <a:pt x="851774" y="956786"/>
                          </a:lnTo>
                          <a:cubicBezTo>
                            <a:pt x="851774" y="960675"/>
                            <a:pt x="855663" y="968454"/>
                            <a:pt x="855663" y="976232"/>
                          </a:cubicBezTo>
                          <a:cubicBezTo>
                            <a:pt x="855663" y="1019016"/>
                            <a:pt x="820659" y="1054020"/>
                            <a:pt x="777876" y="1054020"/>
                          </a:cubicBezTo>
                          <a:cubicBezTo>
                            <a:pt x="742872" y="1054020"/>
                            <a:pt x="711757" y="1026795"/>
                            <a:pt x="703977" y="995680"/>
                          </a:cubicBezTo>
                          <a:lnTo>
                            <a:pt x="622301" y="657304"/>
                          </a:lnTo>
                          <a:lnTo>
                            <a:pt x="622301" y="1750218"/>
                          </a:lnTo>
                          <a:lnTo>
                            <a:pt x="466726" y="1750218"/>
                          </a:lnTo>
                          <a:lnTo>
                            <a:pt x="466726" y="1050131"/>
                          </a:lnTo>
                          <a:lnTo>
                            <a:pt x="388938" y="1050131"/>
                          </a:lnTo>
                          <a:lnTo>
                            <a:pt x="388938" y="1750218"/>
                          </a:lnTo>
                          <a:lnTo>
                            <a:pt x="233363" y="1750218"/>
                          </a:lnTo>
                          <a:lnTo>
                            <a:pt x="233363" y="661193"/>
                          </a:lnTo>
                          <a:lnTo>
                            <a:pt x="151686" y="999569"/>
                          </a:lnTo>
                          <a:cubicBezTo>
                            <a:pt x="143907" y="1030684"/>
                            <a:pt x="112792" y="1057910"/>
                            <a:pt x="77788" y="1057910"/>
                          </a:cubicBezTo>
                          <a:cubicBezTo>
                            <a:pt x="35004" y="1057910"/>
                            <a:pt x="0" y="1022905"/>
                            <a:pt x="0" y="980123"/>
                          </a:cubicBezTo>
                          <a:cubicBezTo>
                            <a:pt x="0" y="972343"/>
                            <a:pt x="3889" y="964564"/>
                            <a:pt x="3889" y="960675"/>
                          </a:cubicBezTo>
                          <a:lnTo>
                            <a:pt x="112792" y="497840"/>
                          </a:lnTo>
                          <a:cubicBezTo>
                            <a:pt x="116682" y="482281"/>
                            <a:pt x="124460" y="466725"/>
                            <a:pt x="136129" y="455057"/>
                          </a:cubicBezTo>
                          <a:cubicBezTo>
                            <a:pt x="182801" y="416162"/>
                            <a:pt x="237252" y="385047"/>
                            <a:pt x="299482" y="369490"/>
                          </a:cubicBezTo>
                          <a:cubicBezTo>
                            <a:pt x="342265" y="357821"/>
                            <a:pt x="385049" y="350043"/>
                            <a:pt x="427832" y="350043"/>
                          </a:cubicBezTo>
                          <a:close/>
                          <a:moveTo>
                            <a:pt x="427831" y="0"/>
                          </a:moveTo>
                          <a:cubicBezTo>
                            <a:pt x="513753" y="0"/>
                            <a:pt x="583406" y="69653"/>
                            <a:pt x="583406" y="155575"/>
                          </a:cubicBezTo>
                          <a:cubicBezTo>
                            <a:pt x="583406" y="241496"/>
                            <a:pt x="513753" y="311150"/>
                            <a:pt x="427831" y="311150"/>
                          </a:cubicBezTo>
                          <a:cubicBezTo>
                            <a:pt x="341910" y="311150"/>
                            <a:pt x="272256" y="241496"/>
                            <a:pt x="272256" y="155575"/>
                          </a:cubicBezTo>
                          <a:cubicBezTo>
                            <a:pt x="272256" y="69653"/>
                            <a:pt x="341910" y="0"/>
                            <a:pt x="427831" y="0"/>
                          </a:cubicBezTo>
                          <a:close/>
                        </a:path>
                      </a:pathLst>
                    </a:custGeom>
                    <a:solidFill>
                      <a:srgbClr val="65AA00"/>
                    </a:solidFill>
                    <a:ln w="15081" cap="flat">
                      <a:noFill/>
                      <a:prstDash val="solid"/>
                      <a:miter/>
                    </a:ln>
                  </p:spPr>
                  <p:txBody>
                    <a:bodyPr wrap="square" rtlCol="0" anchor="ctr">
                      <a:noAutofit/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14" name="Rectangle 13">
                      <a:extLst>
                        <a:ext uri="{FF2B5EF4-FFF2-40B4-BE49-F238E27FC236}">
                          <a16:creationId xmlns:a16="http://schemas.microsoft.com/office/drawing/2014/main" id="{D45FB9E7-8531-4B29-9738-D6347E9F27D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418271" y="1807140"/>
                      <a:ext cx="1162212" cy="455554"/>
                    </a:xfrm>
                    <a:prstGeom prst="rect">
                      <a:avLst/>
                    </a:prstGeom>
                    <a:solidFill>
                      <a:srgbClr val="65AA00"/>
                    </a:solidFill>
                    <a:ln w="41275">
                      <a:solidFill>
                        <a:srgbClr val="65AA00"/>
                      </a:solidFill>
                      <a:round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GB" sz="1600" dirty="0"/>
                        <a:t>Ravulizumab</a:t>
                      </a:r>
                    </a:p>
                    <a:p>
                      <a:pPr algn="ctr"/>
                      <a:r>
                        <a:rPr lang="en-GB" sz="1600" dirty="0"/>
                        <a:t>Every 4–8 weeks</a:t>
                      </a:r>
                    </a:p>
                  </p:txBody>
                </p:sp>
              </p:grpSp>
              <p:pic>
                <p:nvPicPr>
                  <p:cNvPr id="80" name="Graphic 79" descr="IV">
                    <a:extLst>
                      <a:ext uri="{FF2B5EF4-FFF2-40B4-BE49-F238E27FC236}">
                        <a16:creationId xmlns:a16="http://schemas.microsoft.com/office/drawing/2014/main" id="{BA0CE839-D302-4F34-9402-DC9D64EAE63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 cstate="hq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  <a:ext uri="{96DAC541-7B7A-43D3-8B79-37D633B846F1}">
                        <asvg:svgBlip xmlns:asvg="http://schemas.microsoft.com/office/drawing/2016/SVG/main" xmlns="" r:embed="rId8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273877" y="1763062"/>
                    <a:ext cx="659005" cy="659005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89" name="Graphic 88" descr="IV">
                  <a:extLst>
                    <a:ext uri="{FF2B5EF4-FFF2-40B4-BE49-F238E27FC236}">
                      <a16:creationId xmlns:a16="http://schemas.microsoft.com/office/drawing/2014/main" id="{00965F4C-BB85-4E97-B256-5A1B4458299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xmlns="" r:embed="rId1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55116" y="1743373"/>
                  <a:ext cx="659005" cy="659005"/>
                </a:xfrm>
                <a:prstGeom prst="rect">
                  <a:avLst/>
                </a:prstGeom>
              </p:spPr>
            </p:pic>
          </p:grpSp>
        </p:grp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1147B7AF-6233-4B7A-BAC8-70DE9B288638}"/>
              </a:ext>
            </a:extLst>
          </p:cNvPr>
          <p:cNvGrpSpPr/>
          <p:nvPr/>
        </p:nvGrpSpPr>
        <p:grpSpPr>
          <a:xfrm>
            <a:off x="2422045" y="1744528"/>
            <a:ext cx="1864315" cy="654984"/>
            <a:chOff x="2422045" y="1721973"/>
            <a:chExt cx="1864315" cy="65498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D704F61-A92D-4A8F-AA29-314405DEF8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1269" t="10999" r="10640" b="8886"/>
            <a:stretch/>
          </p:blipFill>
          <p:spPr>
            <a:xfrm>
              <a:off x="2422045" y="1721973"/>
              <a:ext cx="638437" cy="654984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2F161AD7-99DB-466E-ADDD-4DF0391B3A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1269" t="10999" r="10640" b="8886"/>
            <a:stretch/>
          </p:blipFill>
          <p:spPr>
            <a:xfrm>
              <a:off x="3034984" y="1721973"/>
              <a:ext cx="638437" cy="654984"/>
            </a:xfrm>
            <a:prstGeom prst="rect">
              <a:avLst/>
            </a:prstGeom>
          </p:spPr>
        </p:pic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32AEC801-F20C-4C60-A372-8241E05A27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1269" t="10999" r="10640" b="8886"/>
            <a:stretch/>
          </p:blipFill>
          <p:spPr>
            <a:xfrm>
              <a:off x="3647923" y="1721973"/>
              <a:ext cx="638437" cy="654984"/>
            </a:xfrm>
            <a:prstGeom prst="rect">
              <a:avLst/>
            </a:prstGeom>
          </p:spPr>
        </p:pic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52D1B37E-C477-4D91-9041-19926173C14B}"/>
              </a:ext>
            </a:extLst>
          </p:cNvPr>
          <p:cNvGrpSpPr/>
          <p:nvPr/>
        </p:nvGrpSpPr>
        <p:grpSpPr>
          <a:xfrm>
            <a:off x="10259040" y="1744528"/>
            <a:ext cx="1882237" cy="654984"/>
            <a:chOff x="10259040" y="1750787"/>
            <a:chExt cx="1882237" cy="654984"/>
          </a:xfrm>
        </p:grpSpPr>
        <p:pic>
          <p:nvPicPr>
            <p:cNvPr id="37" name="Graphic 36" descr="Monthly calendar">
              <a:extLst>
                <a:ext uri="{FF2B5EF4-FFF2-40B4-BE49-F238E27FC236}">
                  <a16:creationId xmlns:a16="http://schemas.microsoft.com/office/drawing/2014/main" id="{0457505D-8D31-413F-95BB-4E082B6C84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hqprint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xmlns="" r:embed="rId13"/>
                </a:ext>
              </a:extLst>
            </a:blip>
            <a:srcRect l="9576" t="11537" r="10824" b="11022"/>
            <a:stretch/>
          </p:blipFill>
          <p:spPr>
            <a:xfrm>
              <a:off x="10873133" y="1767099"/>
              <a:ext cx="654051" cy="636324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369FED2-E148-417A-A01A-BB1B5A6134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9652" t="9644" r="11233" b="10859"/>
            <a:stretch/>
          </p:blipFill>
          <p:spPr>
            <a:xfrm>
              <a:off x="10259040" y="1750787"/>
              <a:ext cx="658355" cy="654984"/>
            </a:xfrm>
            <a:prstGeom prst="rect">
              <a:avLst/>
            </a:prstGeom>
          </p:spPr>
        </p:pic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EB5C2BFD-8260-41BE-972B-8F237304EE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9652" t="9644" r="11233" b="10859"/>
            <a:stretch/>
          </p:blipFill>
          <p:spPr>
            <a:xfrm>
              <a:off x="11482922" y="1750787"/>
              <a:ext cx="658355" cy="65498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056317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95BED2DB6AC1E46890D712BED990AD4" ma:contentTypeVersion="10" ma:contentTypeDescription="Create a new document." ma:contentTypeScope="" ma:versionID="43fb8476a0c76ee676b2b0afbcc88a18">
  <xsd:schema xmlns:xsd="http://www.w3.org/2001/XMLSchema" xmlns:xs="http://www.w3.org/2001/XMLSchema" xmlns:p="http://schemas.microsoft.com/office/2006/metadata/properties" xmlns:ns2="43929ec2-b8a7-48be-bef5-1409c903ed7f" xmlns:ns3="484b87ea-b7f7-4118-ad09-0dd909707dad" targetNamespace="http://schemas.microsoft.com/office/2006/metadata/properties" ma:root="true" ma:fieldsID="437d512993bc5f3270d525c66e1e94da" ns2:_="" ns3:_="">
    <xsd:import namespace="43929ec2-b8a7-48be-bef5-1409c903ed7f"/>
    <xsd:import namespace="484b87ea-b7f7-4118-ad09-0dd909707da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3929ec2-b8a7-48be-bef5-1409c903ed7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4b87ea-b7f7-4118-ad09-0dd909707dad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B7A9557-C2B9-4D63-BB20-F91BF6D99B82}">
  <ds:schemaRefs>
    <ds:schemaRef ds:uri="http://schemas.microsoft.com/office/2006/documentManagement/types"/>
    <ds:schemaRef ds:uri="http://purl.org/dc/terms/"/>
    <ds:schemaRef ds:uri="http://www.w3.org/XML/1998/namespace"/>
    <ds:schemaRef ds:uri="http://schemas.microsoft.com/office/2006/metadata/properties"/>
    <ds:schemaRef ds:uri="http://purl.org/dc/elements/1.1/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484b87ea-b7f7-4118-ad09-0dd909707dad"/>
    <ds:schemaRef ds:uri="43929ec2-b8a7-48be-bef5-1409c903ed7f"/>
  </ds:schemaRefs>
</ds:datastoreItem>
</file>

<file path=customXml/itemProps2.xml><?xml version="1.0" encoding="utf-8"?>
<ds:datastoreItem xmlns:ds="http://schemas.openxmlformats.org/officeDocument/2006/customXml" ds:itemID="{D46583B0-8687-4047-B906-1C191DFBEB1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B41835A-E310-4D6B-A58B-A89DF9F5904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3929ec2-b8a7-48be-bef5-1409c903ed7f"/>
    <ds:schemaRef ds:uri="484b87ea-b7f7-4118-ad09-0dd909707da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575</TotalTime>
  <Words>184</Words>
  <Application>Microsoft Office PowerPoint</Application>
  <PresentationFormat>Widescreen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 Hardy</dc:creator>
  <cp:lastModifiedBy>Joseph Laycock</cp:lastModifiedBy>
  <cp:revision>1</cp:revision>
  <dcterms:created xsi:type="dcterms:W3CDTF">2020-08-25T08:40:31Z</dcterms:created>
  <dcterms:modified xsi:type="dcterms:W3CDTF">2020-09-10T12:12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95BED2DB6AC1E46890D712BED990AD4</vt:lpwstr>
  </property>
</Properties>
</file>